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owkat\Dropbox\miRNA%20Wild%20rice%20data\All%20in%20One\MS\Tajima%20Tes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Sheet1!$H$20:$H$21</c:f>
              <c:strCache>
                <c:ptCount val="2"/>
                <c:pt idx="0">
                  <c:v>Wild Oryza species</c:v>
                </c:pt>
                <c:pt idx="1">
                  <c:v>Cultivated rice</c:v>
                </c:pt>
              </c:strCache>
            </c:strRef>
          </c:cat>
          <c:val>
            <c:numRef>
              <c:f>Sheet1!$I$20:$I$21</c:f>
              <c:numCache>
                <c:formatCode>General</c:formatCode>
                <c:ptCount val="2"/>
                <c:pt idx="0">
                  <c:v>4.2394545454545483E-2</c:v>
                </c:pt>
                <c:pt idx="1">
                  <c:v>5.7518181818181843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907392"/>
        <c:axId val="70908928"/>
      </c:barChart>
      <c:catAx>
        <c:axId val="709073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 baseline="0"/>
            </a:pPr>
            <a:endParaRPr lang="en-US"/>
          </a:p>
        </c:txPr>
        <c:crossAx val="70908928"/>
        <c:crosses val="autoZero"/>
        <c:auto val="1"/>
        <c:lblAlgn val="ctr"/>
        <c:lblOffset val="100"/>
        <c:noMultiLvlLbl val="0"/>
      </c:catAx>
      <c:valAx>
        <c:axId val="709089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IN" sz="1400" b="1" dirty="0" smtClean="0"/>
                  <a:t>Av. Nucleotide </a:t>
                </a:r>
                <a:r>
                  <a:rPr lang="en-IN" sz="1400" b="1" dirty="0"/>
                  <a:t>sequence diver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09073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286000" y="381000"/>
            <a:ext cx="5410200" cy="5335726"/>
            <a:chOff x="2286000" y="1295400"/>
            <a:chExt cx="5410200" cy="5335726"/>
          </a:xfrm>
        </p:grpSpPr>
        <p:sp>
          <p:nvSpPr>
            <p:cNvPr id="9" name="Rectangle 8"/>
            <p:cNvSpPr/>
            <p:nvPr/>
          </p:nvSpPr>
          <p:spPr>
            <a:xfrm>
              <a:off x="2313277" y="4876800"/>
              <a:ext cx="5382923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b="1" smtClean="0">
                  <a:latin typeface="Times New Roman" pitchFamily="18" charset="0"/>
                  <a:cs typeface="Times New Roman" pitchFamily="18" charset="0"/>
                </a:rPr>
                <a:t>Figure </a:t>
              </a:r>
              <a:r>
                <a:rPr lang="en-IN" b="1" dirty="0" smtClean="0">
                  <a:latin typeface="Times New Roman" pitchFamily="18" charset="0"/>
                  <a:cs typeface="Times New Roman" pitchFamily="18" charset="0"/>
                </a:rPr>
                <a:t>S5.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The average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nucleotide sequence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diversity (</a:t>
              </a:r>
              <a:r>
                <a:rPr lang="en-IN" i="1" dirty="0">
                  <a:latin typeface="Times New Roman" pitchFamily="18" charset="0"/>
                  <a:cs typeface="Times New Roman" pitchFamily="18" charset="0"/>
                </a:rPr>
                <a:t>π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) at the 11 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miRNA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loci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(showing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significantly negative values for both the neutrality tests) in cultivated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rice and wild </a:t>
              </a:r>
              <a:r>
                <a:rPr lang="en-IN" i="1" dirty="0" err="1" smtClean="0">
                  <a:latin typeface="Times New Roman" pitchFamily="18" charset="0"/>
                  <a:cs typeface="Times New Roman" pitchFamily="18" charset="0"/>
                </a:rPr>
                <a:t>Oryza</a:t>
              </a:r>
              <a:r>
                <a:rPr lang="en-IN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species. The figure depicts that nucleotide diversity at these significant loci has been considerably lost during the domestication.</a:t>
              </a:r>
              <a:endParaRPr lang="en-IN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2674283"/>
                </p:ext>
              </p:extLst>
            </p:nvPr>
          </p:nvGraphicFramePr>
          <p:xfrm>
            <a:off x="2286000" y="1295400"/>
            <a:ext cx="5181600" cy="3429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904565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kat</dc:creator>
  <cp:lastModifiedBy>Balindan, Danica Joy</cp:lastModifiedBy>
  <cp:revision>9</cp:revision>
  <dcterms:created xsi:type="dcterms:W3CDTF">2006-08-16T00:00:00Z</dcterms:created>
  <dcterms:modified xsi:type="dcterms:W3CDTF">2017-08-30T15:16:20Z</dcterms:modified>
</cp:coreProperties>
</file>